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1404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797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532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264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63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591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918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658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864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088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384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642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E8431-A717-4B55-9ACB-C82752BCB5DE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6892D-F9C6-4B9A-9BC7-6D4F15FFA2E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143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912421A9-44A1-1208-BB94-96F0CE63E8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593" y="978409"/>
            <a:ext cx="6904770" cy="43055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7CCDE49-E95E-C817-5895-CC0941CAD5F4}"/>
              </a:ext>
            </a:extLst>
          </p:cNvPr>
          <p:cNvSpPr txBox="1"/>
          <p:nvPr/>
        </p:nvSpPr>
        <p:spPr>
          <a:xfrm>
            <a:off x="1399594" y="5408595"/>
            <a:ext cx="67274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4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verage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lhouette profile reporting the best number of K-mean clusters (dashed line)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70DBF6-1F81-B9D9-FD45-D1398882FA98}"/>
              </a:ext>
            </a:extLst>
          </p:cNvPr>
          <p:cNvSpPr txBox="1"/>
          <p:nvPr/>
        </p:nvSpPr>
        <p:spPr>
          <a:xfrm>
            <a:off x="76200" y="193212"/>
            <a:ext cx="1813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4</a:t>
            </a:r>
          </a:p>
        </p:txBody>
      </p:sp>
    </p:spTree>
    <p:extLst>
      <p:ext uri="{BB962C8B-B14F-4D97-AF65-F5344CB8AC3E}">
        <p14:creationId xmlns:p14="http://schemas.microsoft.com/office/powerpoint/2010/main" val="770510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4</Words>
  <Application>Microsoft Office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</vt:vector>
  </TitlesOfParts>
  <Company>Fondazione Edmund Ma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pulin</dc:creator>
  <cp:lastModifiedBy>lorenzo vittani</cp:lastModifiedBy>
  <cp:revision>4</cp:revision>
  <dcterms:created xsi:type="dcterms:W3CDTF">2022-09-26T13:01:06Z</dcterms:created>
  <dcterms:modified xsi:type="dcterms:W3CDTF">2023-02-20T17:24:54Z</dcterms:modified>
</cp:coreProperties>
</file>